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8999538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75"/>
  </p:normalViewPr>
  <p:slideViewPr>
    <p:cSldViewPr snapToGrid="0" snapToObjects="1">
      <p:cViewPr varScale="1">
        <p:scale>
          <a:sx n="67" d="100"/>
          <a:sy n="67" d="100"/>
        </p:scale>
        <p:origin x="31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D6F8B1-66C8-6C4E-86C0-C97788CAA763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1143000"/>
            <a:ext cx="2276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4CE055-1ED1-6B47-BF4E-B821070E95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03141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290763" y="1143000"/>
            <a:ext cx="22764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4CE055-1ED1-6B47-BF4E-B821070E9506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59649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995312"/>
            <a:ext cx="7649607" cy="4244622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6403623"/>
            <a:ext cx="6749654" cy="294357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770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3664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649111"/>
            <a:ext cx="1940525" cy="10332156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649111"/>
            <a:ext cx="5709082" cy="10332156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76454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9392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3039537"/>
            <a:ext cx="7762102" cy="5071532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8159048"/>
            <a:ext cx="7762102" cy="266699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2364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3245556"/>
            <a:ext cx="3824804" cy="7735712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3245556"/>
            <a:ext cx="3824804" cy="7735712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1562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649114"/>
            <a:ext cx="7762102" cy="2356556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2988734"/>
            <a:ext cx="3807226" cy="1464732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4453467"/>
            <a:ext cx="3807226" cy="65503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2988734"/>
            <a:ext cx="3825976" cy="1464732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4453467"/>
            <a:ext cx="3825976" cy="655037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0414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5525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47398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812800"/>
            <a:ext cx="2902585" cy="284480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755425"/>
            <a:ext cx="4556016" cy="8664222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657600"/>
            <a:ext cx="2902585" cy="6776156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4579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812800"/>
            <a:ext cx="2902585" cy="284480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755425"/>
            <a:ext cx="4556016" cy="8664222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657600"/>
            <a:ext cx="2902585" cy="6776156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1704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649114"/>
            <a:ext cx="7762102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3245556"/>
            <a:ext cx="7762102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1300181"/>
            <a:ext cx="202489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1134E-733D-C34C-B441-625892D2B128}" type="datetimeFigureOut">
              <a:rPr lang="it-IT" smtClean="0"/>
              <a:t>28/07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1300181"/>
            <a:ext cx="3037344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1300181"/>
            <a:ext cx="202489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409F97-F1A2-1D49-8D0D-2E9ACFED4C1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7292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tangolo 5">
            <a:extLst>
              <a:ext uri="{FF2B5EF4-FFF2-40B4-BE49-F238E27FC236}">
                <a16:creationId xmlns:a16="http://schemas.microsoft.com/office/drawing/2014/main" id="{98B03514-4C38-4A4E-8AB2-F5F21A18E255}"/>
              </a:ext>
            </a:extLst>
          </p:cNvPr>
          <p:cNvSpPr/>
          <p:nvPr/>
        </p:nvSpPr>
        <p:spPr>
          <a:xfrm>
            <a:off x="1842294" y="11124262"/>
            <a:ext cx="5314949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. 4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4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Intra-chromosomal LD decay distance (kb) evaluated considering (A) the whole genome, (B) A genome, (C) B genome. Dashed lines indicate the </a:t>
            </a:r>
            <a:r>
              <a:rPr lang="en-US" sz="1400" i="1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400" baseline="300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4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threshold. The intersection point between the decay LD curve and the LD threshold was shown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8B69A172-068B-FD17-C065-4A47248EBF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6607" y="256777"/>
            <a:ext cx="5454929" cy="108309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3637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56</Words>
  <Application>Microsoft Macintosh PowerPoint</Application>
  <PresentationFormat>Personalizzato</PresentationFormat>
  <Paragraphs>2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Salvatore Esposito</cp:lastModifiedBy>
  <cp:revision>4</cp:revision>
  <dcterms:created xsi:type="dcterms:W3CDTF">2022-05-09T08:21:24Z</dcterms:created>
  <dcterms:modified xsi:type="dcterms:W3CDTF">2022-07-28T07:23:44Z</dcterms:modified>
</cp:coreProperties>
</file>